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7" d="100"/>
          <a:sy n="57" d="100"/>
        </p:scale>
        <p:origin x="-2160" y="2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B02A3-A026-448B-999F-DCA98E5EEBF9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DE215-0A2C-44EE-BD69-69A7514298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6965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B02A3-A026-448B-999F-DCA98E5EEBF9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DE215-0A2C-44EE-BD69-69A7514298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0867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B02A3-A026-448B-999F-DCA98E5EEBF9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DE215-0A2C-44EE-BD69-69A7514298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3227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B02A3-A026-448B-999F-DCA98E5EEBF9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DE215-0A2C-44EE-BD69-69A7514298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1825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B02A3-A026-448B-999F-DCA98E5EEBF9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DE215-0A2C-44EE-BD69-69A7514298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31653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B02A3-A026-448B-999F-DCA98E5EEBF9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DE215-0A2C-44EE-BD69-69A7514298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7752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B02A3-A026-448B-999F-DCA98E5EEBF9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DE215-0A2C-44EE-BD69-69A7514298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4964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B02A3-A026-448B-999F-DCA98E5EEBF9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DE215-0A2C-44EE-BD69-69A7514298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72966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B02A3-A026-448B-999F-DCA98E5EEBF9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DE215-0A2C-44EE-BD69-69A7514298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0884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B02A3-A026-448B-999F-DCA98E5EEBF9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DE215-0A2C-44EE-BD69-69A7514298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6017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B02A3-A026-448B-999F-DCA98E5EEBF9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DE215-0A2C-44EE-BD69-69A7514298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7754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4B02A3-A026-448B-999F-DCA98E5EEBF9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5DE215-0A2C-44EE-BD69-69A7514298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5505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9972" y="6948264"/>
            <a:ext cx="28600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Fig: </a:t>
            </a:r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ildhood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hropometric </a:t>
            </a:r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utcome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2130" y="1820564"/>
            <a:ext cx="29258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Childhood head circumference (7 – 9yrs)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470556" y="1820564"/>
            <a:ext cx="2943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 Childhood chest circumference (7 – 9yrs)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887" y="4378171"/>
            <a:ext cx="29594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Childhood waist circumference (7 – 9yrs)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476865" y="4382755"/>
            <a:ext cx="24657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ldhood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ist:height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7 – 9yrs)</a:t>
            </a:r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829" y="2295164"/>
            <a:ext cx="3299231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5861" y="2318976"/>
            <a:ext cx="3195100" cy="1347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30" y="5107063"/>
            <a:ext cx="3327930" cy="1362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10812" y="5107063"/>
            <a:ext cx="3230149" cy="1333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992729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3</TotalTime>
  <Words>45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16</cp:revision>
  <cp:lastPrinted>2019-05-01T07:39:34Z</cp:lastPrinted>
  <dcterms:created xsi:type="dcterms:W3CDTF">2019-02-21T16:33:32Z</dcterms:created>
  <dcterms:modified xsi:type="dcterms:W3CDTF">2019-06-08T18:48:24Z</dcterms:modified>
</cp:coreProperties>
</file>